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70" r:id="rId3"/>
    <p:sldId id="271" r:id="rId4"/>
    <p:sldId id="272" r:id="rId5"/>
    <p:sldId id="276" r:id="rId6"/>
    <p:sldId id="278" r:id="rId7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4" autoAdjust="0"/>
    <p:restoredTop sz="94660"/>
  </p:normalViewPr>
  <p:slideViewPr>
    <p:cSldViewPr snapToGrid="0">
      <p:cViewPr>
        <p:scale>
          <a:sx n="60" d="100"/>
          <a:sy n="60" d="100"/>
        </p:scale>
        <p:origin x="840" y="1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95CCB-8582-4665-8876-1B04F34AB08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DFFEE-CE3F-4E3C-860E-3A52A60DDD67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95D65-4E17-4BBC-AA3C-883089F61AB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2105D-7F47-4285-BE5D-3092F063053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19.jpeg"/><Relationship Id="rId4" Type="http://schemas.openxmlformats.org/officeDocument/2006/relationships/image" Target="../media/image18.png"/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67640" y="33655"/>
            <a:ext cx="3637915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Supplemental Figure 1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3" name="图片 2" descr="图示&#10;&#10;AI 生成的内容可能不正确。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2206" y="1003815"/>
            <a:ext cx="7536158" cy="5354003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67640" y="33655"/>
            <a:ext cx="3637915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Supplemental Figure 2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3" name="图片 2" descr="图表, 散点图&#10;&#10;AI 生成的内容可能不正确。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6597" y="927100"/>
            <a:ext cx="8553450" cy="57023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67640" y="33655"/>
            <a:ext cx="3637915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Supplemental Figure 3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41655" y="642620"/>
            <a:ext cx="3353435" cy="289623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5175" y="642620"/>
            <a:ext cx="3041650" cy="27178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53705" y="642620"/>
            <a:ext cx="3070860" cy="269113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8325" y="3718560"/>
            <a:ext cx="3465830" cy="298005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77055" y="3780155"/>
            <a:ext cx="3197225" cy="278003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57210" y="3689350"/>
            <a:ext cx="3338830" cy="287083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60655" y="615315"/>
            <a:ext cx="42989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A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103370" y="6464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B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793990" y="655955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C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955280" y="36563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F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141470" y="371348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E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55270" y="36944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D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167640" y="33655"/>
            <a:ext cx="3637915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Supplemental Figure 4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60655" y="615315"/>
            <a:ext cx="42989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A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103370" y="6464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B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998460" y="655955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C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8088630" y="36563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微软雅黑" panose="020B0503020204020204" charset="-122"/>
                <a:ea typeface="微软雅黑" panose="020B0503020204020204" charset="-122"/>
              </a:rPr>
              <a:t>F.</a:t>
            </a:r>
            <a:endParaRPr lang="en-US" altLang="zh-CN" sz="2400" b="1" dirty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141470" y="371348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E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55270" y="36944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D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22" name="内容占位符 21" descr="图表, 箱线图&#10;&#10;AI 生成的内容可能不正确。"/>
          <p:cNvPicPr>
            <a:picLocks noGrp="1" noChangeAspect="1"/>
          </p:cNvPicPr>
          <p:nvPr>
            <p:ph idx="1"/>
          </p:nvPr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8035" y="3656330"/>
            <a:ext cx="3454400" cy="3118485"/>
          </a:xfrm>
        </p:spPr>
      </p:pic>
      <p:pic>
        <p:nvPicPr>
          <p:cNvPr id="24" name="图片 23" descr="图表, 箱线图&#10;&#10;AI 生成的内容可能不正确。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8035" y="540210"/>
            <a:ext cx="3308984" cy="2756450"/>
          </a:xfrm>
          <a:prstGeom prst="rect">
            <a:avLst/>
          </a:prstGeom>
        </p:spPr>
      </p:pic>
      <p:pic>
        <p:nvPicPr>
          <p:cNvPr id="26" name="图片 25" descr="图表, 箱线图&#10;&#10;AI 生成的内容可能不正确。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550" y="655955"/>
            <a:ext cx="3215005" cy="2773045"/>
          </a:xfrm>
          <a:prstGeom prst="rect">
            <a:avLst/>
          </a:prstGeom>
        </p:spPr>
      </p:pic>
      <p:pic>
        <p:nvPicPr>
          <p:cNvPr id="28" name="图片 27" descr="图表, 箱线图&#10;&#10;AI 生成的内容可能不正确。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203" y="3656330"/>
            <a:ext cx="3410266" cy="3152457"/>
          </a:xfrm>
          <a:prstGeom prst="rect">
            <a:avLst/>
          </a:prstGeom>
        </p:spPr>
      </p:pic>
      <p:pic>
        <p:nvPicPr>
          <p:cNvPr id="30" name="图片 29" descr="图表, 箱线图&#10;&#10;AI 生成的内容可能不正确。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1524" y="3593696"/>
            <a:ext cx="3171191" cy="3264304"/>
          </a:xfrm>
          <a:prstGeom prst="rect">
            <a:avLst/>
          </a:prstGeom>
        </p:spPr>
      </p:pic>
      <p:pic>
        <p:nvPicPr>
          <p:cNvPr id="32" name="图片 31" descr="图表, 箱线图&#10;&#10;AI 生成的内容可能不正确。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1524" y="567305"/>
            <a:ext cx="3308985" cy="297718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9065" y="605155"/>
            <a:ext cx="3784600" cy="283845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3665" y="541655"/>
            <a:ext cx="4075430" cy="290957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95895" y="605155"/>
            <a:ext cx="4308475" cy="302450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065" y="3757930"/>
            <a:ext cx="4039870" cy="303339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67640" y="33655"/>
            <a:ext cx="3637915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Supplemental Figure 5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46380" y="462915"/>
            <a:ext cx="42989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A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189095" y="408305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B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8013065" y="41783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C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331970" y="3589655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E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55270" y="3561080"/>
            <a:ext cx="4781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微软雅黑" panose="020B0503020204020204" charset="-122"/>
                <a:ea typeface="微软雅黑" panose="020B0503020204020204" charset="-122"/>
              </a:rPr>
              <a:t>D.</a:t>
            </a:r>
            <a:endParaRPr lang="en-US" altLang="zh-CN" sz="2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8" name="图片 7" descr="图表&#10;&#10;AI 生成的内容可能不正确。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3160" y="4021454"/>
            <a:ext cx="4566603" cy="283654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mNjZTM1MDFjMzExNDU2NzczODQ3N2YzYWY2MmYxMWE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</Words>
  <Application>WPS 演示</Application>
  <PresentationFormat>宽屏</PresentationFormat>
  <Paragraphs>44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微软雅黑</vt:lpstr>
      <vt:lpstr>Arial Unicode MS</vt:lpstr>
      <vt:lpstr>等线 Light</vt:lpstr>
      <vt:lpstr>等线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3521892979</dc:creator>
  <cp:lastModifiedBy>author</cp:lastModifiedBy>
  <cp:revision>59</cp:revision>
  <dcterms:created xsi:type="dcterms:W3CDTF">2025-07-04T09:09:00Z</dcterms:created>
  <dcterms:modified xsi:type="dcterms:W3CDTF">2026-01-30T22:39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68C962576CE4C7C9B6EBFB8262FD1DB</vt:lpwstr>
  </property>
  <property fmtid="{D5CDD505-2E9C-101B-9397-08002B2CF9AE}" pid="3" name="KSOProductBuildVer">
    <vt:lpwstr>2052-12.1.0.24657</vt:lpwstr>
  </property>
</Properties>
</file>